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12192000" cy="6858000"/>
  <p:notesSz cx="6858000" cy="9144000"/>
  <p:defaultTextStyle>
    <a:defPPr>
      <a:defRPr lang="fa-I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RT Pack 20 DVDs" initials="MP2D" lastIdx="1" clrIdx="0">
    <p:extLst>
      <p:ext uri="{19B8F6BF-5375-455C-9EA6-DF929625EA0E}">
        <p15:presenceInfo xmlns:p15="http://schemas.microsoft.com/office/powerpoint/2012/main" userId="MRT Pack 20 DVDs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2466" autoAdjust="0"/>
  </p:normalViewPr>
  <p:slideViewPr>
    <p:cSldViewPr snapToGrid="0">
      <p:cViewPr varScale="1">
        <p:scale>
          <a:sx n="57" d="100"/>
          <a:sy n="57" d="100"/>
        </p:scale>
        <p:origin x="1152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endParaRPr lang="fa-I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fld id="{3582F1FA-6D48-448C-970A-66BE609E95DD}" type="datetimeFigureOut">
              <a:rPr lang="fa-IR" smtClean="0"/>
              <a:t>06/13/1441</a:t>
            </a:fld>
            <a:endParaRPr lang="fa-I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a-I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a-I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endParaRPr lang="fa-I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fld id="{3C074EB9-6B0F-4569-A951-7A63C87761FC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26347501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C074EB9-6B0F-4569-A951-7A63C87761FC}" type="slidenum">
              <a:rPr lang="fa-IR" smtClean="0"/>
              <a:t>1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241523632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fa-IR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fa-I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06/13/1441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14992347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a-I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a-I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06/13/1441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5617887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fa-I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a-I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06/13/1441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37540411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a-I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a-I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06/13/1441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13671694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fa-I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06/13/1441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11042833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a-IR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a-IR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a-IR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06/13/1441</a:t>
            </a:fld>
            <a:endParaRPr lang="fa-I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4387173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fa-I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a-IR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a-IR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06/13/1441</a:t>
            </a:fld>
            <a:endParaRPr lang="fa-I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21897034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a-IR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06/13/1441</a:t>
            </a:fld>
            <a:endParaRPr lang="fa-I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3692865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06/13/1441</a:t>
            </a:fld>
            <a:endParaRPr lang="fa-I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25406404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fa-I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a-IR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06/13/1441</a:t>
            </a:fld>
            <a:endParaRPr lang="fa-I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12002215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fa-IR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a-IR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06/13/1441</a:t>
            </a:fld>
            <a:endParaRPr lang="fa-I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16288242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fa-I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a-I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3623DA-C239-499A-8DAB-661F72BF1177}" type="datetimeFigureOut">
              <a:rPr lang="fa-IR" smtClean="0"/>
              <a:t>06/13/1441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10565403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a-I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Description: C:\Users\hossein\Desktop\2016-05-11_12-23-42.png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72692" y="130390"/>
            <a:ext cx="5070764" cy="5259013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TextBox 4"/>
          <p:cNvSpPr txBox="1"/>
          <p:nvPr/>
        </p:nvSpPr>
        <p:spPr>
          <a:xfrm>
            <a:off x="1011382" y="5380672"/>
            <a:ext cx="10377054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+mj-cs"/>
              </a:rPr>
              <a:t>Fig S2. </a:t>
            </a:r>
            <a:r>
              <a:rPr lang="en-US" dirty="0" smtClean="0">
                <a:effectLst/>
                <a:latin typeface="Times New Roman" panose="02020603050405020304" pitchFamily="18" charset="0"/>
                <a:cs typeface="+mj-cs"/>
              </a:rPr>
              <a:t>ProSA local model quality/residue-wise energy plot shows most of the residues have negative energy.</a:t>
            </a:r>
          </a:p>
        </p:txBody>
      </p:sp>
    </p:spTree>
    <p:extLst>
      <p:ext uri="{BB962C8B-B14F-4D97-AF65-F5344CB8AC3E}">
        <p14:creationId xmlns:p14="http://schemas.microsoft.com/office/powerpoint/2010/main" val="33402157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44</TotalTime>
  <Words>19</Words>
  <Application>Microsoft Office PowerPoint</Application>
  <PresentationFormat>Widescreen</PresentationFormat>
  <Paragraphs>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MRT www.Win2Farsi.co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RT Pack 20 DVDs</dc:creator>
  <cp:lastModifiedBy>User</cp:lastModifiedBy>
  <cp:revision>82</cp:revision>
  <dcterms:created xsi:type="dcterms:W3CDTF">2019-03-24T09:48:42Z</dcterms:created>
  <dcterms:modified xsi:type="dcterms:W3CDTF">2020-02-07T07:34:20Z</dcterms:modified>
</cp:coreProperties>
</file>